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0605" autoAdjust="0"/>
  </p:normalViewPr>
  <p:slideViewPr>
    <p:cSldViewPr snapToGrid="0">
      <p:cViewPr varScale="1">
        <p:scale>
          <a:sx n="91" d="100"/>
          <a:sy n="91" d="100"/>
        </p:scale>
        <p:origin x="13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DE0155-DD5B-45D9-B834-608798009024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7454F4-C9B4-45BA-BBED-6C18CF8CBF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6397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Supplementary Figure 1. Flow of selecting proteomic candidates subjected to latent class analysis</a:t>
            </a:r>
          </a:p>
          <a:p>
            <a:r>
              <a:rPr lang="en-US" altLang="ko-KR" dirty="0"/>
              <a:t>Abbreviations: PAR = Peak area ratio</a:t>
            </a:r>
          </a:p>
          <a:p>
            <a:r>
              <a:rPr lang="en-US" altLang="ko-KR" baseline="30000" dirty="0" err="1"/>
              <a:t>a</a:t>
            </a:r>
            <a:r>
              <a:rPr lang="en-US" altLang="ko-KR" dirty="0" err="1"/>
              <a:t>controlled</a:t>
            </a:r>
            <a:r>
              <a:rPr lang="en-US" altLang="ko-KR" dirty="0"/>
              <a:t> for age, sex, body mass index, blood collection time, fasting time, alcohol use, exercise, smoking behavior</a:t>
            </a: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aseline="30000" dirty="0" err="1"/>
              <a:t>b</a:t>
            </a:r>
            <a:r>
              <a:rPr lang="en-US" altLang="ko-KR" dirty="0" err="1"/>
              <a:t>controlled</a:t>
            </a:r>
            <a:r>
              <a:rPr lang="en-US" altLang="ko-KR" dirty="0"/>
              <a:t> for age, sex, body mass index, blood collection time, fasting time, alcohol use, exercise, smoking behavior, and hospital type</a:t>
            </a:r>
          </a:p>
          <a:p>
            <a:endParaRPr lang="en-US" altLang="ko-KR" dirty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7454F4-C9B4-45BA-BBED-6C18CF8CBFF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4303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71F1B23-7406-EEC0-1CB4-FA0749FF43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D03E274-AE44-43D2-173C-F7B7C37068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CC7F069-5139-30C9-99BD-4B11B2E69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DAD74C6-C23C-85DE-E924-6F10DFB55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9C6483-3AA9-4C4D-C23B-4D5CD0AF9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6905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BA58A56-A336-FB65-0844-CB5024A015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7EABD12-AD87-993A-7A7E-321F79906C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428A36F-F923-8A81-6262-BD5C0A074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E95F85A-77F8-FF30-2695-E842C3CEF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A2B315-75B0-81E7-FE26-75707ADB0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335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7439BBF-CA3A-CC7A-936E-E293F170ED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1F545BD-C130-F2D0-AE37-B9C3F301A6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6416DEB-3AFA-466E-A7B1-F00BCFF2D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CB3259-4129-3CEA-E7CB-A5DCAFDA8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C81CF9E-BFBF-189C-1EEF-690735401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5468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39A58A-1FE1-A7D3-AE99-A2484E89AF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47EF0BB-5052-1803-F977-C52207F868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DC6126E-C0B5-DB9F-9AC0-B8F29AE42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133E32-87CE-F10A-A0B2-D5C1FB794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3924B83-310D-6DEA-4ECF-4B4366C0B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7026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493F99-DC19-B70A-C0B4-6460B7D97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AA39577-E10C-6A90-B493-497695A97A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52AC51-E268-B75B-4CAF-6D11832AD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F878344-A9B2-3D6E-0309-6AB5AEA2A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58ABF7-2247-935A-E9A9-6C544A9D8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7452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D2F9B10-8AF6-E58F-315F-BA0FF7131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87FD3AA-D11D-5617-B378-62A26AEBB9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823AA73-55AF-A806-D8CC-7791CDE95A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A99BAD2-EE06-DF2A-1C07-4727BCBE0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B2A1FF7-F5E3-F83E-E69B-A63AEC817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6846A3F-503F-28D4-981F-2033C8E43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697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E484DD-B34D-43F3-6CCD-C96F38E98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66D6AC3-7498-61AE-DA80-72F2586FD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492C8BB-BD80-899A-30B4-7B242D0047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4065608-DF91-3C82-1C6D-9766D5FC3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CB4F036-B792-0CB7-E9DB-440C55FEAE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93F8199-9295-5109-0272-CBDC07201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E46C929-36EB-4613-31CA-16CCE9829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16C83D8-B028-4291-66BD-F0DF03338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6899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D95095-BDD8-17EF-7E07-2086AE7D5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95F211F-86B0-B010-C56F-B101E912B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296089-4E16-2E6A-FE01-ACDD89ADD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B4C540D-7C97-159B-9A04-BE55D6C44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9807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D4F99AB-0F9A-1BEB-B0BD-3EA28A7B2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0D85957-6D64-9FE7-CE1A-858DF5CCB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7D385A6-DB87-4E22-3F5A-3EFAF7297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3486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FB93DB-5A72-F895-EC28-2BE6123D8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BCF5F44-8B00-C4E8-E32A-1188648061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4322052-B374-159F-DA8B-115675E21F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B0DE277-54B5-0839-AD3E-5D09E8130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10305B4-DDBE-B003-3549-0F0A6B798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CCF4779-2645-EFBC-B895-C8BEFE765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10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E71F51-4B69-904B-0F3F-5430F9C457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DFD9850-1705-5323-45F5-EE3093CA57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5506A75-0EAB-5B7C-BBFB-20ECBF20F5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B2ED4B3-2F1A-655D-A665-40BAA7BB4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D1CF339-EF96-966B-6364-9DACD8EB2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8DF4D4-C2CF-B7D3-C3BB-CF04B4A07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0225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D86A5A6-08DA-4E4C-6155-0EE1C912ED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61A8AB0-7E18-9E38-A637-212B868F3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A4AEAF9-1119-E63F-B99D-D27550C24E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EA45C-42D0-48AB-857B-18D70646D162}" type="datetimeFigureOut">
              <a:rPr lang="ko-KR" altLang="en-US" smtClean="0"/>
              <a:t>2022-08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9C13A49-35A6-D9C5-0FFF-11A0C7E670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588C714-4CA0-BB04-C113-590F7C873A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C08AA4-57F7-4E19-8711-964728D509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143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FECA48ED-68C1-963A-E4E2-82EBDA7F3E09}"/>
              </a:ext>
            </a:extLst>
          </p:cNvPr>
          <p:cNvGrpSpPr/>
          <p:nvPr/>
        </p:nvGrpSpPr>
        <p:grpSpPr>
          <a:xfrm>
            <a:off x="2992032" y="0"/>
            <a:ext cx="5682717" cy="6481453"/>
            <a:chOff x="37919" y="699762"/>
            <a:chExt cx="5854776" cy="5574800"/>
          </a:xfrm>
        </p:grpSpPr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1E1C03CA-9A80-53DA-7288-DC20504A78A7}"/>
                </a:ext>
              </a:extLst>
            </p:cNvPr>
            <p:cNvSpPr/>
            <p:nvPr/>
          </p:nvSpPr>
          <p:spPr>
            <a:xfrm>
              <a:off x="37919" y="699762"/>
              <a:ext cx="5854776" cy="5574800"/>
            </a:xfrm>
            <a:prstGeom prst="rect">
              <a:avLst/>
            </a:prstGeom>
            <a:solidFill>
              <a:srgbClr val="DEDED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A21310B7-D879-A281-2BE1-45CB313AE881}"/>
                </a:ext>
              </a:extLst>
            </p:cNvPr>
            <p:cNvSpPr/>
            <p:nvPr/>
          </p:nvSpPr>
          <p:spPr>
            <a:xfrm>
              <a:off x="179513" y="836712"/>
              <a:ext cx="2304255" cy="44170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73288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0000"/>
                </a:lnSpc>
              </a:pP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itial proteomic candidates</a:t>
              </a:r>
            </a:p>
            <a:p>
              <a:pPr algn="ctr">
                <a:lnSpc>
                  <a:spcPct val="120000"/>
                </a:lnSpc>
              </a:pP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588 peptides)</a:t>
              </a:r>
              <a:endParaRPr lang="ko-KR" altLang="en-US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직선 화살표 연결선 6">
              <a:extLst>
                <a:ext uri="{FF2B5EF4-FFF2-40B4-BE49-F238E27FC236}">
                  <a16:creationId xmlns:a16="http://schemas.microsoft.com/office/drawing/2014/main" id="{4BBDBB53-62FE-1B50-91DF-61BD246B02D0}"/>
                </a:ext>
              </a:extLst>
            </p:cNvPr>
            <p:cNvCxnSpPr>
              <a:cxnSpLocks/>
              <a:endCxn id="18" idx="0"/>
            </p:cNvCxnSpPr>
            <p:nvPr/>
          </p:nvCxnSpPr>
          <p:spPr>
            <a:xfrm>
              <a:off x="1334383" y="1278421"/>
              <a:ext cx="25177" cy="4235650"/>
            </a:xfrm>
            <a:prstGeom prst="straightConnector1">
              <a:avLst/>
            </a:prstGeom>
            <a:ln w="19050">
              <a:solidFill>
                <a:srgbClr val="732888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FAE9027F-86F1-CB07-CDC6-39C7A1EB4EE7}"/>
                </a:ext>
              </a:extLst>
            </p:cNvPr>
            <p:cNvSpPr/>
            <p:nvPr/>
          </p:nvSpPr>
          <p:spPr>
            <a:xfrm>
              <a:off x="168059" y="2628509"/>
              <a:ext cx="2338140" cy="463138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73288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ct val="120000"/>
                </a:lnSpc>
              </a:pP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101 peptides)</a:t>
              </a:r>
              <a:endParaRPr lang="ko-KR" altLang="en-US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직선 화살표 연결선 8">
              <a:extLst>
                <a:ext uri="{FF2B5EF4-FFF2-40B4-BE49-F238E27FC236}">
                  <a16:creationId xmlns:a16="http://schemas.microsoft.com/office/drawing/2014/main" id="{C1B1A111-5990-4336-1054-3B54D153938E}"/>
                </a:ext>
              </a:extLst>
            </p:cNvPr>
            <p:cNvCxnSpPr/>
            <p:nvPr/>
          </p:nvCxnSpPr>
          <p:spPr>
            <a:xfrm>
              <a:off x="1348112" y="1509559"/>
              <a:ext cx="1440000" cy="0"/>
            </a:xfrm>
            <a:prstGeom prst="straightConnector1">
              <a:avLst/>
            </a:prstGeom>
            <a:ln w="19050">
              <a:solidFill>
                <a:srgbClr val="732888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AD421D71-FE01-9270-5675-0A88190B41AB}"/>
                </a:ext>
              </a:extLst>
            </p:cNvPr>
            <p:cNvSpPr/>
            <p:nvPr/>
          </p:nvSpPr>
          <p:spPr>
            <a:xfrm>
              <a:off x="2774384" y="1280879"/>
              <a:ext cx="2978682" cy="45736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80975">
                <a:lnSpc>
                  <a:spcPct val="120000"/>
                </a:lnSpc>
              </a:pP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 proteins with PAR &lt; 0.01 or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or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 least 5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cent</a:t>
              </a:r>
              <a:r>
                <a:rPr lang="ko-KR" altLang="en-US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05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f patient/controls</a:t>
              </a:r>
            </a:p>
          </p:txBody>
        </p:sp>
        <p:cxnSp>
          <p:nvCxnSpPr>
            <p:cNvPr id="11" name="직선 화살표 연결선 10">
              <a:extLst>
                <a:ext uri="{FF2B5EF4-FFF2-40B4-BE49-F238E27FC236}">
                  <a16:creationId xmlns:a16="http://schemas.microsoft.com/office/drawing/2014/main" id="{135B8205-4AD7-B0C3-7B54-96C1D0237003}"/>
                </a:ext>
              </a:extLst>
            </p:cNvPr>
            <p:cNvCxnSpPr/>
            <p:nvPr/>
          </p:nvCxnSpPr>
          <p:spPr>
            <a:xfrm>
              <a:off x="1359560" y="2449238"/>
              <a:ext cx="1440000" cy="0"/>
            </a:xfrm>
            <a:prstGeom prst="straightConnector1">
              <a:avLst/>
            </a:prstGeom>
            <a:ln w="19050">
              <a:solidFill>
                <a:srgbClr val="732888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1F3FD320-BF42-453F-8470-7A181898FDD9}"/>
              </a:ext>
            </a:extLst>
          </p:cNvPr>
          <p:cNvSpPr/>
          <p:nvPr/>
        </p:nvSpPr>
        <p:spPr>
          <a:xfrm>
            <a:off x="5672515" y="1748788"/>
            <a:ext cx="2877594" cy="570426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80975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nonsignificant proteins with patient/controls in a univariate analysis</a:t>
            </a: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A5AE5ADF-D23C-5307-B62F-4CD497729A9E}"/>
              </a:ext>
            </a:extLst>
          </p:cNvPr>
          <p:cNvSpPr/>
          <p:nvPr/>
        </p:nvSpPr>
        <p:spPr>
          <a:xfrm>
            <a:off x="3129465" y="1232629"/>
            <a:ext cx="2236538" cy="531741"/>
          </a:xfrm>
          <a:prstGeom prst="rect">
            <a:avLst/>
          </a:prstGeom>
          <a:solidFill>
            <a:schemeClr val="bg1"/>
          </a:solidFill>
          <a:ln w="19050">
            <a:solidFill>
              <a:srgbClr val="73288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455 peptides)</a:t>
            </a:r>
            <a:endParaRPr lang="ko-KR" altLang="en-US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CE07635F-9800-F831-6550-888FB2B09F3C}"/>
              </a:ext>
            </a:extLst>
          </p:cNvPr>
          <p:cNvSpPr/>
          <p:nvPr/>
        </p:nvSpPr>
        <p:spPr>
          <a:xfrm>
            <a:off x="5659358" y="2724212"/>
            <a:ext cx="2877594" cy="570423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80975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nonsignificant proteins with patient/controls in a multivariate analysis controlled for </a:t>
            </a:r>
            <a:r>
              <a:rPr lang="en-US" altLang="ko-KR" sz="105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variates</a:t>
            </a:r>
            <a:r>
              <a:rPr lang="en-US" altLang="ko-KR" sz="1050" baseline="3000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ko-KR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12EBB35F-9DB9-326D-A69F-8820167FF465}"/>
              </a:ext>
            </a:extLst>
          </p:cNvPr>
          <p:cNvCxnSpPr/>
          <p:nvPr/>
        </p:nvCxnSpPr>
        <p:spPr>
          <a:xfrm>
            <a:off x="4274833" y="3009423"/>
            <a:ext cx="1397682" cy="0"/>
          </a:xfrm>
          <a:prstGeom prst="straightConnector1">
            <a:avLst/>
          </a:prstGeom>
          <a:ln w="19050">
            <a:solidFill>
              <a:srgbClr val="732888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9DA79C34-5661-1BDE-57EC-5D63C78D7180}"/>
              </a:ext>
            </a:extLst>
          </p:cNvPr>
          <p:cNvSpPr/>
          <p:nvPr/>
        </p:nvSpPr>
        <p:spPr>
          <a:xfrm>
            <a:off x="3118346" y="3354896"/>
            <a:ext cx="2269427" cy="538460"/>
          </a:xfrm>
          <a:prstGeom prst="rect">
            <a:avLst/>
          </a:prstGeom>
          <a:solidFill>
            <a:schemeClr val="bg1"/>
          </a:solidFill>
          <a:ln w="19050">
            <a:solidFill>
              <a:srgbClr val="73288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30 peptides)</a:t>
            </a:r>
            <a:endParaRPr lang="ko-KR" altLang="en-US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ED58B78B-6BD4-BC70-EAC2-F21367F54E39}"/>
              </a:ext>
            </a:extLst>
          </p:cNvPr>
          <p:cNvSpPr/>
          <p:nvPr/>
        </p:nvSpPr>
        <p:spPr>
          <a:xfrm>
            <a:off x="3140120" y="5597281"/>
            <a:ext cx="2269426" cy="495704"/>
          </a:xfrm>
          <a:prstGeom prst="rect">
            <a:avLst/>
          </a:prstGeom>
          <a:solidFill>
            <a:schemeClr val="bg1"/>
          </a:solidFill>
          <a:ln w="19050">
            <a:solidFill>
              <a:srgbClr val="73288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nal proteomic candidates</a:t>
            </a:r>
          </a:p>
          <a:p>
            <a:pPr algn="ctr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2 peptides)</a:t>
            </a:r>
            <a:endParaRPr lang="ko-KR" altLang="en-US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E15E4573-7E23-206A-4F52-2FDDECD42C12}"/>
              </a:ext>
            </a:extLst>
          </p:cNvPr>
          <p:cNvCxnSpPr/>
          <p:nvPr/>
        </p:nvCxnSpPr>
        <p:spPr>
          <a:xfrm>
            <a:off x="4250396" y="4164502"/>
            <a:ext cx="1397682" cy="0"/>
          </a:xfrm>
          <a:prstGeom prst="straightConnector1">
            <a:avLst/>
          </a:prstGeom>
          <a:ln w="19050">
            <a:solidFill>
              <a:srgbClr val="732888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D9D604E2-3FCE-8E97-34E7-08FB721E2F9A}"/>
              </a:ext>
            </a:extLst>
          </p:cNvPr>
          <p:cNvSpPr/>
          <p:nvPr/>
        </p:nvSpPr>
        <p:spPr>
          <a:xfrm>
            <a:off x="5648078" y="3879290"/>
            <a:ext cx="2870176" cy="570423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80975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nonsignificant proteins with patient/controls in a multivariate analysis additionally controlled for hospital </a:t>
            </a:r>
            <a:r>
              <a:rPr lang="en-US" altLang="ko-KR" sz="105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n-US" altLang="ko-KR" sz="1050" baseline="3000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ko-KR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4CF6B544-A7D0-35E1-411E-C64F81E72D81}"/>
              </a:ext>
            </a:extLst>
          </p:cNvPr>
          <p:cNvSpPr/>
          <p:nvPr/>
        </p:nvSpPr>
        <p:spPr>
          <a:xfrm>
            <a:off x="3096576" y="4391469"/>
            <a:ext cx="2269427" cy="538460"/>
          </a:xfrm>
          <a:prstGeom prst="rect">
            <a:avLst/>
          </a:prstGeom>
          <a:solidFill>
            <a:schemeClr val="bg1"/>
          </a:solidFill>
          <a:ln w="19050">
            <a:solidFill>
              <a:srgbClr val="73288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8 peptides)</a:t>
            </a:r>
            <a:endParaRPr lang="ko-KR" altLang="en-US" sz="105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C027ED9B-13BC-3557-35AF-582EAFDE991D}"/>
              </a:ext>
            </a:extLst>
          </p:cNvPr>
          <p:cNvSpPr/>
          <p:nvPr/>
        </p:nvSpPr>
        <p:spPr>
          <a:xfrm>
            <a:off x="5648078" y="4944096"/>
            <a:ext cx="2891947" cy="570423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80975">
              <a:lnSpc>
                <a:spcPct val="120000"/>
              </a:lnSpc>
            </a:pPr>
            <a:r>
              <a:rPr lang="en-US" altLang="ko-KR" sz="105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significant proteins with hospital type in a univariate analysis, only in patients</a:t>
            </a: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2123A2C3-1894-7003-356C-32D2EB48F44B}"/>
              </a:ext>
            </a:extLst>
          </p:cNvPr>
          <p:cNvCxnSpPr/>
          <p:nvPr/>
        </p:nvCxnSpPr>
        <p:spPr>
          <a:xfrm>
            <a:off x="4274833" y="5229307"/>
            <a:ext cx="1397682" cy="0"/>
          </a:xfrm>
          <a:prstGeom prst="straightConnector1">
            <a:avLst/>
          </a:prstGeom>
          <a:ln w="19050">
            <a:solidFill>
              <a:srgbClr val="732888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EC2ABCD-8D21-4AD1-8785-F37986E22593}"/>
              </a:ext>
            </a:extLst>
          </p:cNvPr>
          <p:cNvSpPr txBox="1"/>
          <p:nvPr/>
        </p:nvSpPr>
        <p:spPr>
          <a:xfrm>
            <a:off x="9072438" y="3103493"/>
            <a:ext cx="2837793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mentary Figure 1. </a:t>
            </a:r>
            <a:r>
              <a:rPr lang="en-US" altLang="ko-KR" sz="1200" dirty="0"/>
              <a:t>Flow of selecting proteomic candidates subjected to latent class analysis</a:t>
            </a:r>
          </a:p>
          <a:p>
            <a:endParaRPr lang="en-US" altLang="ko-KR" sz="1200" dirty="0"/>
          </a:p>
          <a:p>
            <a:r>
              <a:rPr lang="en-US" altLang="ko-KR" sz="1200" dirty="0"/>
              <a:t>Abbreviations: PAR = Peak area ratio</a:t>
            </a:r>
          </a:p>
          <a:p>
            <a:endParaRPr lang="en-US" altLang="ko-KR" sz="1200" dirty="0"/>
          </a:p>
          <a:p>
            <a:r>
              <a:rPr lang="en-US" altLang="ko-KR" sz="1200" baseline="30000" dirty="0" err="1"/>
              <a:t>a</a:t>
            </a:r>
            <a:r>
              <a:rPr lang="en-US" altLang="ko-KR" sz="1200" dirty="0" err="1"/>
              <a:t>controlled</a:t>
            </a:r>
            <a:r>
              <a:rPr lang="en-US" altLang="ko-KR" sz="1200" dirty="0"/>
              <a:t> for age, sex, body mass index, blood collection time, fasting time, alcohol use, exercise, smoking behavior</a:t>
            </a:r>
          </a:p>
          <a:p>
            <a:endParaRPr lang="en-US" altLang="ko-KR" sz="1200" dirty="0"/>
          </a:p>
          <a:p>
            <a:pPr lvl="0">
              <a:defRPr/>
            </a:pPr>
            <a:r>
              <a:rPr lang="en-US" altLang="ko-KR" sz="1200" baseline="30000" dirty="0" err="1"/>
              <a:t>b</a:t>
            </a:r>
            <a:r>
              <a:rPr lang="en-US" altLang="ko-KR" sz="1200" dirty="0" err="1"/>
              <a:t>controlled</a:t>
            </a:r>
            <a:r>
              <a:rPr lang="en-US" altLang="ko-KR" sz="1200" dirty="0"/>
              <a:t> for age, sex, body mass index, blood collection time, fasting time, alcohol use, exercise, smoking behavior, and hospital type</a:t>
            </a:r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3337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250</Words>
  <Application>Microsoft Office PowerPoint</Application>
  <PresentationFormat>와이드스크린</PresentationFormat>
  <Paragraphs>2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HEE SANG JIN</dc:creator>
  <cp:lastModifiedBy>Rhee</cp:lastModifiedBy>
  <cp:revision>15</cp:revision>
  <dcterms:created xsi:type="dcterms:W3CDTF">2022-05-27T03:04:47Z</dcterms:created>
  <dcterms:modified xsi:type="dcterms:W3CDTF">2022-08-22T08:43:27Z</dcterms:modified>
</cp:coreProperties>
</file>